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9E632-1BE5-4F39-A6BD-F3159223BD7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C57405-F26B-4FF8-AC3A-362063B46DA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8FECB-AD1C-4A08-93A0-62782CC3901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96B9B-C5E2-4504-BD55-1C432E0C52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08909-3AEE-4F31-8494-33CE2CDD6D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4B320-09BF-479A-AA8F-9467FE293E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BD4A00-A5A3-4228-AC74-4B55218594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C74282-A617-4384-8C1A-FF70709595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AFBBDE-571A-470E-9310-4049238F09C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226F0-098B-4351-A40F-389D9CF628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14CEDD-E924-4DC6-BC92-D7FBC3AE7C6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CA5377-445A-48BB-8DC3-D2F0B6FCCA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D752B2-619E-43CA-9259-F6B6E522412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06000" y="18432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742320" y="514440"/>
            <a:ext cx="4577400" cy="6788160"/>
            <a:chOff x="742320" y="514440"/>
            <a:chExt cx="4577400" cy="6788160"/>
          </a:xfrm>
        </p:grpSpPr>
        <p:grpSp>
          <p:nvGrpSpPr>
            <p:cNvPr id="43" name=""/>
            <p:cNvGrpSpPr/>
            <p:nvPr/>
          </p:nvGrpSpPr>
          <p:grpSpPr>
            <a:xfrm>
              <a:off x="742320" y="514440"/>
              <a:ext cx="4577400" cy="6788160"/>
              <a:chOff x="742320" y="514440"/>
              <a:chExt cx="4577400" cy="6788160"/>
            </a:xfrm>
          </p:grpSpPr>
          <p:sp>
            <p:nvSpPr>
              <p:cNvPr id="44" name=""/>
              <p:cNvSpPr/>
              <p:nvPr/>
            </p:nvSpPr>
            <p:spPr>
              <a:xfrm>
                <a:off x="742320" y="514440"/>
                <a:ext cx="38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</a:rPr>
                  <a:t>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"/>
              <p:cNvSpPr/>
              <p:nvPr/>
            </p:nvSpPr>
            <p:spPr>
              <a:xfrm>
                <a:off x="1806840" y="574560"/>
                <a:ext cx="20412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Distribution of tree lengths for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768240" y="1011240"/>
                <a:ext cx="4394160" cy="2886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1492200" y="1170000"/>
                <a:ext cx="3535560" cy="2022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1492200" y="1170000"/>
                <a:ext cx="3535560" cy="2022480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1652760" y="3181320"/>
                <a:ext cx="10800" cy="1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4417920" y="3162240"/>
                <a:ext cx="11160" cy="30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4448160" y="3181320"/>
                <a:ext cx="19080" cy="1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4467240" y="3181320"/>
                <a:ext cx="19080" cy="1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4486320" y="3152880"/>
                <a:ext cx="19080" cy="396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4505400" y="3112920"/>
                <a:ext cx="19080" cy="795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524480" y="2975040"/>
                <a:ext cx="7920" cy="217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532400" y="2994120"/>
                <a:ext cx="20520" cy="1983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552920" y="2835360"/>
                <a:ext cx="17640" cy="3571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570560" y="2587680"/>
                <a:ext cx="20520" cy="604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4591080" y="2508120"/>
                <a:ext cx="17280" cy="6843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4608360" y="2033640"/>
                <a:ext cx="20880" cy="11588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4629240" y="1994040"/>
                <a:ext cx="7920" cy="1198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4637160" y="1824120"/>
                <a:ext cx="20520" cy="13683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4657680" y="1963800"/>
                <a:ext cx="17640" cy="12286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4675320" y="2073240"/>
                <a:ext cx="20520" cy="1119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695840" y="1784520"/>
                <a:ext cx="17280" cy="14079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713120" y="2101680"/>
                <a:ext cx="20880" cy="1090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4734000" y="2487600"/>
                <a:ext cx="17280" cy="7048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4751280" y="2716200"/>
                <a:ext cx="9720" cy="476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4761000" y="2874960"/>
                <a:ext cx="19080" cy="3175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4780080" y="2975040"/>
                <a:ext cx="19080" cy="217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4799160" y="3141720"/>
                <a:ext cx="19080" cy="507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4818240" y="3162240"/>
                <a:ext cx="18720" cy="30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4836960" y="3162240"/>
                <a:ext cx="19080" cy="30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4865760" y="3181320"/>
                <a:ext cx="20520" cy="1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1614600" y="3181320"/>
                <a:ext cx="20520" cy="111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2451240" y="3181320"/>
                <a:ext cx="20520" cy="111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2471760" y="3162240"/>
                <a:ext cx="17280" cy="302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2489040" y="3141720"/>
                <a:ext cx="20880" cy="507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2509920" y="3043080"/>
                <a:ext cx="17280" cy="1494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2527200" y="2975040"/>
                <a:ext cx="9720" cy="2174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2536920" y="2725560"/>
                <a:ext cx="19080" cy="4669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2556000" y="2637000"/>
                <a:ext cx="19080" cy="5554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2575080" y="2131920"/>
                <a:ext cx="18720" cy="10605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2593800" y="1716120"/>
                <a:ext cx="19080" cy="14763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2612880" y="1447920"/>
                <a:ext cx="19080" cy="17445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2631960" y="1596960"/>
                <a:ext cx="19080" cy="15955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651040" y="1566720"/>
                <a:ext cx="11160" cy="16257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2662200" y="1704960"/>
                <a:ext cx="17640" cy="14875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2679840" y="1943280"/>
                <a:ext cx="20520" cy="12492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2700360" y="2716200"/>
                <a:ext cx="17280" cy="4762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2717640" y="2954160"/>
                <a:ext cx="19080" cy="2383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2736720" y="3054240"/>
                <a:ext cx="19080" cy="1382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2755800" y="3162240"/>
                <a:ext cx="9720" cy="302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2765520" y="3181320"/>
                <a:ext cx="19080" cy="111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1492200" y="1170000"/>
                <a:ext cx="1800" cy="2022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1444680" y="319248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1444680" y="294336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1444680" y="268596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1444680" y="243828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1444680" y="218124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1444680" y="193356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1444680" y="167652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1444680" y="142704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1444680" y="117000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1492200" y="3192480"/>
                <a:ext cx="3535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 flipV="1">
                <a:off x="1492200" y="3192120"/>
                <a:ext cx="180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 flipV="1">
                <a:off x="184320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 flipV="1">
                <a:off x="2193840" y="3192120"/>
                <a:ext cx="180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 flipV="1">
                <a:off x="253692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V="1">
                <a:off x="288936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flipV="1">
                <a:off x="324180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V="1">
                <a:off x="3592440" y="3192120"/>
                <a:ext cx="180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 flipV="1">
                <a:off x="394344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V="1">
                <a:off x="429588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 flipV="1">
                <a:off x="463716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flipV="1">
                <a:off x="498960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1334880" y="311292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1257840" y="286380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1257840" y="260676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1257840" y="23590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1257840" y="21016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1182240" y="185436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1182240" y="159696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1182240" y="134928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1182240" y="109044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142020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17726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21236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246636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281736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316980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5204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38714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422388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456516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49190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082680" y="3578400"/>
                <a:ext cx="470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Lengt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 rot="16200000">
                <a:off x="648720" y="2043720"/>
                <a:ext cx="723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requenc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3830760" y="1209600"/>
                <a:ext cx="1207800" cy="468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3876840" y="1289160"/>
                <a:ext cx="88560" cy="91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4043520" y="1249200"/>
                <a:ext cx="834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ull data se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3876840" y="1517760"/>
                <a:ext cx="88560" cy="903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4043880" y="1477800"/>
                <a:ext cx="107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lone correc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1901160" y="1897200"/>
                <a:ext cx="55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bserv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1902960" y="2050920"/>
                <a:ext cx="680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full data set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1902600" y="2203560"/>
                <a:ext cx="31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= 10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1600920" y="1293840"/>
                <a:ext cx="55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bserv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1601640" y="1446120"/>
                <a:ext cx="9014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lone correct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1601280" y="1598760"/>
                <a:ext cx="803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data set = 10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1585800" y="1774800"/>
                <a:ext cx="76320" cy="1351080"/>
              </a:xfrm>
              <a:custGeom>
                <a:avLst/>
                <a:gdLst/>
                <a:ahLst/>
                <a:rect l="l" t="t" r="r" b="b"/>
                <a:pathLst>
                  <a:path w="96" h="1702">
                    <a:moveTo>
                      <a:pt x="56" y="8"/>
                    </a:moveTo>
                    <a:lnTo>
                      <a:pt x="56" y="1622"/>
                    </a:lnTo>
                    <a:lnTo>
                      <a:pt x="56" y="1626"/>
                    </a:lnTo>
                    <a:lnTo>
                      <a:pt x="54" y="1628"/>
                    </a:lnTo>
                    <a:lnTo>
                      <a:pt x="52" y="1629"/>
                    </a:lnTo>
                    <a:lnTo>
                      <a:pt x="48" y="1629"/>
                    </a:lnTo>
                    <a:lnTo>
                      <a:pt x="46" y="1629"/>
                    </a:lnTo>
                    <a:lnTo>
                      <a:pt x="42" y="1628"/>
                    </a:lnTo>
                    <a:lnTo>
                      <a:pt x="40" y="1626"/>
                    </a:lnTo>
                    <a:lnTo>
                      <a:pt x="40" y="1622"/>
                    </a:lnTo>
                    <a:lnTo>
                      <a:pt x="40" y="8"/>
                    </a:lnTo>
                    <a:lnTo>
                      <a:pt x="40" y="6"/>
                    </a:lnTo>
                    <a:lnTo>
                      <a:pt x="42" y="2"/>
                    </a:lnTo>
                    <a:lnTo>
                      <a:pt x="46" y="0"/>
                    </a:lnTo>
                    <a:lnTo>
                      <a:pt x="48" y="0"/>
                    </a:lnTo>
                    <a:lnTo>
                      <a:pt x="52" y="0"/>
                    </a:lnTo>
                    <a:lnTo>
                      <a:pt x="54" y="2"/>
                    </a:lnTo>
                    <a:lnTo>
                      <a:pt x="56" y="6"/>
                    </a:lnTo>
                    <a:lnTo>
                      <a:pt x="56" y="8"/>
                    </a:lnTo>
                    <a:lnTo>
                      <a:pt x="56" y="8"/>
                    </a:lnTo>
                    <a:close/>
                    <a:moveTo>
                      <a:pt x="96" y="1606"/>
                    </a:moveTo>
                    <a:lnTo>
                      <a:pt x="48" y="1702"/>
                    </a:lnTo>
                    <a:lnTo>
                      <a:pt x="0" y="1606"/>
                    </a:lnTo>
                    <a:lnTo>
                      <a:pt x="96" y="1606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1676520" y="2343240"/>
                <a:ext cx="284040" cy="806400"/>
              </a:xfrm>
              <a:custGeom>
                <a:avLst/>
                <a:gdLst/>
                <a:ahLst/>
                <a:rect l="l" t="t" r="r" b="b"/>
                <a:pathLst>
                  <a:path w="359" h="1016">
                    <a:moveTo>
                      <a:pt x="359" y="11"/>
                    </a:moveTo>
                    <a:lnTo>
                      <a:pt x="48" y="943"/>
                    </a:lnTo>
                    <a:lnTo>
                      <a:pt x="46" y="945"/>
                    </a:lnTo>
                    <a:lnTo>
                      <a:pt x="44" y="947"/>
                    </a:lnTo>
                    <a:lnTo>
                      <a:pt x="40" y="949"/>
                    </a:lnTo>
                    <a:lnTo>
                      <a:pt x="39" y="949"/>
                    </a:lnTo>
                    <a:lnTo>
                      <a:pt x="35" y="947"/>
                    </a:lnTo>
                    <a:lnTo>
                      <a:pt x="33" y="945"/>
                    </a:lnTo>
                    <a:lnTo>
                      <a:pt x="33" y="941"/>
                    </a:lnTo>
                    <a:lnTo>
                      <a:pt x="33" y="937"/>
                    </a:lnTo>
                    <a:lnTo>
                      <a:pt x="343" y="6"/>
                    </a:lnTo>
                    <a:lnTo>
                      <a:pt x="345" y="2"/>
                    </a:lnTo>
                    <a:lnTo>
                      <a:pt x="347" y="2"/>
                    </a:lnTo>
                    <a:lnTo>
                      <a:pt x="351" y="0"/>
                    </a:lnTo>
                    <a:lnTo>
                      <a:pt x="353" y="0"/>
                    </a:lnTo>
                    <a:lnTo>
                      <a:pt x="357" y="2"/>
                    </a:lnTo>
                    <a:lnTo>
                      <a:pt x="359" y="4"/>
                    </a:lnTo>
                    <a:lnTo>
                      <a:pt x="359" y="7"/>
                    </a:lnTo>
                    <a:lnTo>
                      <a:pt x="359" y="11"/>
                    </a:lnTo>
                    <a:lnTo>
                      <a:pt x="359" y="11"/>
                    </a:lnTo>
                    <a:close/>
                    <a:moveTo>
                      <a:pt x="90" y="941"/>
                    </a:moveTo>
                    <a:lnTo>
                      <a:pt x="16" y="1016"/>
                    </a:lnTo>
                    <a:lnTo>
                      <a:pt x="0" y="911"/>
                    </a:lnTo>
                    <a:lnTo>
                      <a:pt x="90" y="941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1888920" y="4100400"/>
                <a:ext cx="3181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Distribution of tree lengths for eastern Thailan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762120" y="4422600"/>
                <a:ext cx="4478040" cy="2880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1484280" y="4584600"/>
                <a:ext cx="3621240" cy="2040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1484280" y="4584600"/>
                <a:ext cx="3621240" cy="2040120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2300400" y="6615000"/>
                <a:ext cx="11412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3005280" y="6605640"/>
                <a:ext cx="114120" cy="19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3119400" y="6615000"/>
                <a:ext cx="11448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3233880" y="6576840"/>
                <a:ext cx="123840" cy="478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3357720" y="6472080"/>
                <a:ext cx="112680" cy="152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3470400" y="6195960"/>
                <a:ext cx="114120" cy="4287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3584520" y="5977080"/>
                <a:ext cx="123840" cy="647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3708360" y="5300640"/>
                <a:ext cx="114480" cy="1324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3822840" y="5156280"/>
                <a:ext cx="114120" cy="1468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3936960" y="4871880"/>
                <a:ext cx="112680" cy="17528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4049640" y="5432400"/>
                <a:ext cx="123840" cy="1192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4173480" y="5938920"/>
                <a:ext cx="114480" cy="685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4287960" y="6310440"/>
                <a:ext cx="114120" cy="314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4402080" y="6529320"/>
                <a:ext cx="122400" cy="954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4524480" y="6615000"/>
                <a:ext cx="11412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2300400" y="6605640"/>
                <a:ext cx="114120" cy="190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2414520" y="6576840"/>
                <a:ext cx="125640" cy="47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2540160" y="6462720"/>
                <a:ext cx="112680" cy="1620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2652840" y="6356520"/>
                <a:ext cx="114120" cy="2682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2766960" y="5919840"/>
                <a:ext cx="114480" cy="704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2881440" y="5386320"/>
                <a:ext cx="123840" cy="12384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3005280" y="4965840"/>
                <a:ext cx="114120" cy="1658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3119400" y="4976640"/>
                <a:ext cx="114480" cy="16480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3233880" y="5176800"/>
                <a:ext cx="123840" cy="14479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3357720" y="5958000"/>
                <a:ext cx="112680" cy="6667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3470400" y="6386400"/>
                <a:ext cx="114120" cy="2383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3584520" y="6576840"/>
                <a:ext cx="123840" cy="47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3708360" y="6615000"/>
                <a:ext cx="114480" cy="97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1484280" y="4584600"/>
                <a:ext cx="1800" cy="2040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1436760" y="662472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1436760" y="621504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1436760" y="580536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1436760" y="540540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1436760" y="499572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1436760" y="458460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1484280" y="6624720"/>
                <a:ext cx="3621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 flipV="1">
                <a:off x="1484280" y="6624720"/>
                <a:ext cx="180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 flipV="1">
                <a:off x="3822840" y="6624720"/>
                <a:ext cx="144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1330560" y="654840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1257480" y="61387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1185480" y="572940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1185480" y="532908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5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1185480" y="491976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1185480" y="450864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25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150516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7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209412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7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267372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326268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8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384192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9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442296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9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4978080" y="675792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3133440" y="6996240"/>
                <a:ext cx="4291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Length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 rot="16200000">
                <a:off x="663840" y="5462280"/>
                <a:ext cx="6620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Frequency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4030560" y="4491000"/>
                <a:ext cx="1209600" cy="449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4079880" y="4567320"/>
                <a:ext cx="85680" cy="856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4278600" y="4529160"/>
                <a:ext cx="7642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Full data set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4079880" y="4786200"/>
                <a:ext cx="95400" cy="954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4289040" y="4748040"/>
                <a:ext cx="9896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Clone corrected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2449440" y="5160960"/>
                <a:ext cx="125640" cy="1360440"/>
              </a:xfrm>
              <a:custGeom>
                <a:avLst/>
                <a:gdLst/>
                <a:ahLst/>
                <a:rect l="l" t="t" r="r" b="b"/>
                <a:pathLst>
                  <a:path w="157" h="1714">
                    <a:moveTo>
                      <a:pt x="157" y="9"/>
                    </a:moveTo>
                    <a:lnTo>
                      <a:pt x="55" y="1635"/>
                    </a:lnTo>
                    <a:lnTo>
                      <a:pt x="53" y="1637"/>
                    </a:lnTo>
                    <a:lnTo>
                      <a:pt x="51" y="1639"/>
                    </a:lnTo>
                    <a:lnTo>
                      <a:pt x="50" y="1640"/>
                    </a:lnTo>
                    <a:lnTo>
                      <a:pt x="46" y="1640"/>
                    </a:lnTo>
                    <a:lnTo>
                      <a:pt x="44" y="1640"/>
                    </a:lnTo>
                    <a:lnTo>
                      <a:pt x="40" y="1639"/>
                    </a:lnTo>
                    <a:lnTo>
                      <a:pt x="40" y="1637"/>
                    </a:lnTo>
                    <a:lnTo>
                      <a:pt x="38" y="1633"/>
                    </a:lnTo>
                    <a:lnTo>
                      <a:pt x="142" y="7"/>
                    </a:lnTo>
                    <a:lnTo>
                      <a:pt x="142" y="3"/>
                    </a:lnTo>
                    <a:lnTo>
                      <a:pt x="143" y="2"/>
                    </a:lnTo>
                    <a:lnTo>
                      <a:pt x="147" y="0"/>
                    </a:lnTo>
                    <a:lnTo>
                      <a:pt x="151" y="0"/>
                    </a:lnTo>
                    <a:lnTo>
                      <a:pt x="153" y="2"/>
                    </a:lnTo>
                    <a:lnTo>
                      <a:pt x="155" y="3"/>
                    </a:lnTo>
                    <a:lnTo>
                      <a:pt x="157" y="5"/>
                    </a:lnTo>
                    <a:lnTo>
                      <a:pt x="157" y="9"/>
                    </a:lnTo>
                    <a:lnTo>
                      <a:pt x="157" y="9"/>
                    </a:lnTo>
                    <a:close/>
                    <a:moveTo>
                      <a:pt x="96" y="1621"/>
                    </a:moveTo>
                    <a:lnTo>
                      <a:pt x="42" y="1714"/>
                    </a:lnTo>
                    <a:lnTo>
                      <a:pt x="0" y="1614"/>
                    </a:lnTo>
                    <a:lnTo>
                      <a:pt x="96" y="1621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2127960" y="4691160"/>
                <a:ext cx="55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bserv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2128680" y="4843440"/>
                <a:ext cx="9014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lone correct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2128680" y="4995720"/>
                <a:ext cx="733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data set = 7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1696320" y="5342040"/>
                <a:ext cx="55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bserv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1698120" y="5494320"/>
                <a:ext cx="680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full data set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1697760" y="5646600"/>
                <a:ext cx="249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= 7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2027160" y="5815080"/>
                <a:ext cx="335160" cy="750960"/>
              </a:xfrm>
              <a:custGeom>
                <a:avLst/>
                <a:gdLst/>
                <a:ahLst/>
                <a:rect l="l" t="t" r="r" b="b"/>
                <a:pathLst>
                  <a:path w="422" h="945">
                    <a:moveTo>
                      <a:pt x="15" y="6"/>
                    </a:moveTo>
                    <a:lnTo>
                      <a:pt x="391" y="868"/>
                    </a:lnTo>
                    <a:lnTo>
                      <a:pt x="391" y="872"/>
                    </a:lnTo>
                    <a:lnTo>
                      <a:pt x="391" y="874"/>
                    </a:lnTo>
                    <a:lnTo>
                      <a:pt x="389" y="878"/>
                    </a:lnTo>
                    <a:lnTo>
                      <a:pt x="387" y="880"/>
                    </a:lnTo>
                    <a:lnTo>
                      <a:pt x="383" y="880"/>
                    </a:lnTo>
                    <a:lnTo>
                      <a:pt x="379" y="880"/>
                    </a:lnTo>
                    <a:lnTo>
                      <a:pt x="377" y="878"/>
                    </a:lnTo>
                    <a:lnTo>
                      <a:pt x="376" y="874"/>
                    </a:lnTo>
                    <a:lnTo>
                      <a:pt x="0" y="11"/>
                    </a:lnTo>
                    <a:lnTo>
                      <a:pt x="0" y="8"/>
                    </a:lnTo>
                    <a:lnTo>
                      <a:pt x="0" y="6"/>
                    </a:lnTo>
                    <a:lnTo>
                      <a:pt x="2" y="4"/>
                    </a:lnTo>
                    <a:lnTo>
                      <a:pt x="4" y="2"/>
                    </a:lnTo>
                    <a:lnTo>
                      <a:pt x="8" y="0"/>
                    </a:lnTo>
                    <a:lnTo>
                      <a:pt x="11" y="2"/>
                    </a:lnTo>
                    <a:lnTo>
                      <a:pt x="13" y="2"/>
                    </a:lnTo>
                    <a:lnTo>
                      <a:pt x="15" y="6"/>
                    </a:lnTo>
                    <a:lnTo>
                      <a:pt x="15" y="6"/>
                    </a:lnTo>
                    <a:close/>
                    <a:moveTo>
                      <a:pt x="422" y="838"/>
                    </a:moveTo>
                    <a:lnTo>
                      <a:pt x="416" y="945"/>
                    </a:lnTo>
                    <a:lnTo>
                      <a:pt x="333" y="876"/>
                    </a:lnTo>
                    <a:lnTo>
                      <a:pt x="422" y="838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4046400" y="4503600"/>
                <a:ext cx="1273320" cy="411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4046400" y="4503600"/>
                <a:ext cx="1273320" cy="411480"/>
              </a:xfrm>
              <a:prstGeom prst="rect">
                <a:avLst/>
              </a:prstGeom>
              <a:noFill/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1801440" y="574560"/>
                <a:ext cx="32835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Distribution of tree lengths for northern Thailand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768240" y="1011240"/>
                <a:ext cx="4394160" cy="2886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6" name=""/>
              <p:cNvSpPr/>
              <p:nvPr/>
            </p:nvSpPr>
            <p:spPr>
              <a:xfrm>
                <a:off x="1492200" y="1170000"/>
                <a:ext cx="3535560" cy="2022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7" name=""/>
              <p:cNvSpPr/>
              <p:nvPr/>
            </p:nvSpPr>
            <p:spPr>
              <a:xfrm>
                <a:off x="1492200" y="1170000"/>
                <a:ext cx="3535560" cy="2022480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>
                <a:off x="1652760" y="3181320"/>
                <a:ext cx="10800" cy="1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"/>
              <p:cNvSpPr/>
              <p:nvPr/>
            </p:nvSpPr>
            <p:spPr>
              <a:xfrm>
                <a:off x="4417920" y="3162240"/>
                <a:ext cx="11160" cy="30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>
                <a:off x="4448160" y="3181320"/>
                <a:ext cx="19080" cy="1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"/>
              <p:cNvSpPr/>
              <p:nvPr/>
            </p:nvSpPr>
            <p:spPr>
              <a:xfrm>
                <a:off x="4467240" y="3181320"/>
                <a:ext cx="19080" cy="1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"/>
              <p:cNvSpPr/>
              <p:nvPr/>
            </p:nvSpPr>
            <p:spPr>
              <a:xfrm>
                <a:off x="4486320" y="3152880"/>
                <a:ext cx="19080" cy="396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200" bIns="-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>
                <a:off x="4505400" y="3112920"/>
                <a:ext cx="19080" cy="795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"/>
              <p:cNvSpPr/>
              <p:nvPr/>
            </p:nvSpPr>
            <p:spPr>
              <a:xfrm>
                <a:off x="4524480" y="2975040"/>
                <a:ext cx="7920" cy="217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"/>
              <p:cNvSpPr/>
              <p:nvPr/>
            </p:nvSpPr>
            <p:spPr>
              <a:xfrm>
                <a:off x="4532400" y="2994120"/>
                <a:ext cx="20520" cy="1983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"/>
              <p:cNvSpPr/>
              <p:nvPr/>
            </p:nvSpPr>
            <p:spPr>
              <a:xfrm>
                <a:off x="4552920" y="2835360"/>
                <a:ext cx="17640" cy="3571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>
                <a:off x="4570560" y="2587680"/>
                <a:ext cx="20520" cy="604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"/>
              <p:cNvSpPr/>
              <p:nvPr/>
            </p:nvSpPr>
            <p:spPr>
              <a:xfrm>
                <a:off x="4591080" y="2508120"/>
                <a:ext cx="17280" cy="6843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"/>
              <p:cNvSpPr/>
              <p:nvPr/>
            </p:nvSpPr>
            <p:spPr>
              <a:xfrm>
                <a:off x="4608360" y="2033640"/>
                <a:ext cx="20880" cy="11588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"/>
              <p:cNvSpPr/>
              <p:nvPr/>
            </p:nvSpPr>
            <p:spPr>
              <a:xfrm>
                <a:off x="4629240" y="1994040"/>
                <a:ext cx="7920" cy="1198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"/>
              <p:cNvSpPr/>
              <p:nvPr/>
            </p:nvSpPr>
            <p:spPr>
              <a:xfrm>
                <a:off x="4637160" y="1824120"/>
                <a:ext cx="20520" cy="13683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4657680" y="1963800"/>
                <a:ext cx="17640" cy="12286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4675320" y="2073240"/>
                <a:ext cx="20520" cy="1119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4" name=""/>
            <p:cNvGrpSpPr/>
            <p:nvPr/>
          </p:nvGrpSpPr>
          <p:grpSpPr>
            <a:xfrm>
              <a:off x="762120" y="1090440"/>
              <a:ext cx="4557600" cy="6212160"/>
              <a:chOff x="762120" y="1090440"/>
              <a:chExt cx="4557600" cy="6212160"/>
            </a:xfrm>
          </p:grpSpPr>
          <p:sp>
            <p:nvSpPr>
              <p:cNvPr id="245" name=""/>
              <p:cNvSpPr/>
              <p:nvPr/>
            </p:nvSpPr>
            <p:spPr>
              <a:xfrm>
                <a:off x="4695840" y="1784520"/>
                <a:ext cx="17280" cy="14079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>
                <a:off x="4713120" y="2101680"/>
                <a:ext cx="20880" cy="1090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"/>
              <p:cNvSpPr/>
              <p:nvPr/>
            </p:nvSpPr>
            <p:spPr>
              <a:xfrm>
                <a:off x="4734000" y="2487600"/>
                <a:ext cx="17280" cy="7048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"/>
              <p:cNvSpPr/>
              <p:nvPr/>
            </p:nvSpPr>
            <p:spPr>
              <a:xfrm>
                <a:off x="4751280" y="2716200"/>
                <a:ext cx="9720" cy="476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"/>
              <p:cNvSpPr/>
              <p:nvPr/>
            </p:nvSpPr>
            <p:spPr>
              <a:xfrm>
                <a:off x="4761000" y="2874960"/>
                <a:ext cx="19080" cy="3175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>
                <a:off x="4780080" y="2975040"/>
                <a:ext cx="19080" cy="217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"/>
              <p:cNvSpPr/>
              <p:nvPr/>
            </p:nvSpPr>
            <p:spPr>
              <a:xfrm>
                <a:off x="4799160" y="3141720"/>
                <a:ext cx="19080" cy="507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"/>
              <p:cNvSpPr/>
              <p:nvPr/>
            </p:nvSpPr>
            <p:spPr>
              <a:xfrm>
                <a:off x="4818240" y="3162240"/>
                <a:ext cx="18720" cy="30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"/>
              <p:cNvSpPr/>
              <p:nvPr/>
            </p:nvSpPr>
            <p:spPr>
              <a:xfrm>
                <a:off x="4836960" y="3162240"/>
                <a:ext cx="19080" cy="302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>
                <a:off x="4865760" y="3181320"/>
                <a:ext cx="20520" cy="111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5" name=""/>
              <p:cNvSpPr/>
              <p:nvPr/>
            </p:nvSpPr>
            <p:spPr>
              <a:xfrm>
                <a:off x="1614600" y="3181320"/>
                <a:ext cx="20520" cy="111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6" name=""/>
              <p:cNvSpPr/>
              <p:nvPr/>
            </p:nvSpPr>
            <p:spPr>
              <a:xfrm>
                <a:off x="2451240" y="3181320"/>
                <a:ext cx="20520" cy="111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7" name=""/>
              <p:cNvSpPr/>
              <p:nvPr/>
            </p:nvSpPr>
            <p:spPr>
              <a:xfrm>
                <a:off x="2471760" y="3162240"/>
                <a:ext cx="17280" cy="302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2489040" y="3141720"/>
                <a:ext cx="20880" cy="507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"/>
              <p:cNvSpPr/>
              <p:nvPr/>
            </p:nvSpPr>
            <p:spPr>
              <a:xfrm>
                <a:off x="2509920" y="3043080"/>
                <a:ext cx="17280" cy="1494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0" name=""/>
              <p:cNvSpPr/>
              <p:nvPr/>
            </p:nvSpPr>
            <p:spPr>
              <a:xfrm>
                <a:off x="2527200" y="2975040"/>
                <a:ext cx="9720" cy="2174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1" name=""/>
              <p:cNvSpPr/>
              <p:nvPr/>
            </p:nvSpPr>
            <p:spPr>
              <a:xfrm>
                <a:off x="2536920" y="2725560"/>
                <a:ext cx="19080" cy="4669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2556000" y="2637000"/>
                <a:ext cx="19080" cy="5554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3" name=""/>
              <p:cNvSpPr/>
              <p:nvPr/>
            </p:nvSpPr>
            <p:spPr>
              <a:xfrm>
                <a:off x="2575080" y="2131920"/>
                <a:ext cx="18720" cy="10605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4" name=""/>
              <p:cNvSpPr/>
              <p:nvPr/>
            </p:nvSpPr>
            <p:spPr>
              <a:xfrm>
                <a:off x="2593800" y="1716120"/>
                <a:ext cx="19080" cy="14763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5" name=""/>
              <p:cNvSpPr/>
              <p:nvPr/>
            </p:nvSpPr>
            <p:spPr>
              <a:xfrm>
                <a:off x="2612880" y="1447920"/>
                <a:ext cx="19080" cy="17445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2631960" y="1596960"/>
                <a:ext cx="19080" cy="15955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7" name=""/>
              <p:cNvSpPr/>
              <p:nvPr/>
            </p:nvSpPr>
            <p:spPr>
              <a:xfrm>
                <a:off x="2651040" y="1566720"/>
                <a:ext cx="11160" cy="16257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8" name=""/>
              <p:cNvSpPr/>
              <p:nvPr/>
            </p:nvSpPr>
            <p:spPr>
              <a:xfrm>
                <a:off x="2662200" y="1704960"/>
                <a:ext cx="17640" cy="14875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2679840" y="1943280"/>
                <a:ext cx="20520" cy="124920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2700360" y="2716200"/>
                <a:ext cx="17280" cy="47628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"/>
              <p:cNvSpPr/>
              <p:nvPr/>
            </p:nvSpPr>
            <p:spPr>
              <a:xfrm>
                <a:off x="2717640" y="2954160"/>
                <a:ext cx="19080" cy="23832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"/>
              <p:cNvSpPr/>
              <p:nvPr/>
            </p:nvSpPr>
            <p:spPr>
              <a:xfrm>
                <a:off x="2736720" y="3054240"/>
                <a:ext cx="19080" cy="1382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2755800" y="3162240"/>
                <a:ext cx="9720" cy="3024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2765520" y="3181320"/>
                <a:ext cx="19080" cy="111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640" bIns="-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1492200" y="1170000"/>
                <a:ext cx="1800" cy="2022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1444680" y="319248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1444680" y="294336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1444680" y="268596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1444680" y="243828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1444680" y="218124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1444680" y="193356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1444680" y="167652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1444680" y="142704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1444680" y="117000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1492200" y="3192480"/>
                <a:ext cx="353556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 flipV="1">
                <a:off x="1492200" y="3192120"/>
                <a:ext cx="180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"/>
              <p:cNvSpPr/>
              <p:nvPr/>
            </p:nvSpPr>
            <p:spPr>
              <a:xfrm flipV="1">
                <a:off x="184320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"/>
              <p:cNvSpPr/>
              <p:nvPr/>
            </p:nvSpPr>
            <p:spPr>
              <a:xfrm flipV="1">
                <a:off x="2193840" y="3192120"/>
                <a:ext cx="180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"/>
              <p:cNvSpPr/>
              <p:nvPr/>
            </p:nvSpPr>
            <p:spPr>
              <a:xfrm flipV="1">
                <a:off x="253692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"/>
              <p:cNvSpPr/>
              <p:nvPr/>
            </p:nvSpPr>
            <p:spPr>
              <a:xfrm flipV="1">
                <a:off x="288936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"/>
              <p:cNvSpPr/>
              <p:nvPr/>
            </p:nvSpPr>
            <p:spPr>
              <a:xfrm flipV="1">
                <a:off x="324180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"/>
              <p:cNvSpPr/>
              <p:nvPr/>
            </p:nvSpPr>
            <p:spPr>
              <a:xfrm flipV="1">
                <a:off x="3592440" y="3192120"/>
                <a:ext cx="180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"/>
              <p:cNvSpPr/>
              <p:nvPr/>
            </p:nvSpPr>
            <p:spPr>
              <a:xfrm flipV="1">
                <a:off x="394344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 flipV="1">
                <a:off x="429588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"/>
              <p:cNvSpPr/>
              <p:nvPr/>
            </p:nvSpPr>
            <p:spPr>
              <a:xfrm flipV="1">
                <a:off x="463716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"/>
              <p:cNvSpPr/>
              <p:nvPr/>
            </p:nvSpPr>
            <p:spPr>
              <a:xfrm flipV="1">
                <a:off x="4989600" y="3192120"/>
                <a:ext cx="1440" cy="493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1334880" y="3112920"/>
                <a:ext cx="86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"/>
              <p:cNvSpPr/>
              <p:nvPr/>
            </p:nvSpPr>
            <p:spPr>
              <a:xfrm>
                <a:off x="1257840" y="286380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"/>
              <p:cNvSpPr/>
              <p:nvPr/>
            </p:nvSpPr>
            <p:spPr>
              <a:xfrm>
                <a:off x="1257840" y="260676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"/>
              <p:cNvSpPr/>
              <p:nvPr/>
            </p:nvSpPr>
            <p:spPr>
              <a:xfrm>
                <a:off x="1257840" y="23590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1257840" y="2101680"/>
                <a:ext cx="1713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>
                <a:off x="1182240" y="185436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"/>
              <p:cNvSpPr/>
              <p:nvPr/>
            </p:nvSpPr>
            <p:spPr>
              <a:xfrm>
                <a:off x="1182240" y="159696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1182240" y="134928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1182240" y="109044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6" name=""/>
              <p:cNvSpPr/>
              <p:nvPr/>
            </p:nvSpPr>
            <p:spPr>
              <a:xfrm>
                <a:off x="142020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"/>
              <p:cNvSpPr/>
              <p:nvPr/>
            </p:nvSpPr>
            <p:spPr>
              <a:xfrm>
                <a:off x="17726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"/>
              <p:cNvSpPr/>
              <p:nvPr/>
            </p:nvSpPr>
            <p:spPr>
              <a:xfrm>
                <a:off x="21236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>
                <a:off x="246636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"/>
              <p:cNvSpPr/>
              <p:nvPr/>
            </p:nvSpPr>
            <p:spPr>
              <a:xfrm>
                <a:off x="281736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"/>
              <p:cNvSpPr/>
              <p:nvPr/>
            </p:nvSpPr>
            <p:spPr>
              <a:xfrm>
                <a:off x="316980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"/>
              <p:cNvSpPr/>
              <p:nvPr/>
            </p:nvSpPr>
            <p:spPr>
              <a:xfrm>
                <a:off x="35204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2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>
                <a:off x="38714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4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"/>
              <p:cNvSpPr/>
              <p:nvPr/>
            </p:nvSpPr>
            <p:spPr>
              <a:xfrm>
                <a:off x="422388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6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"/>
              <p:cNvSpPr/>
              <p:nvPr/>
            </p:nvSpPr>
            <p:spPr>
              <a:xfrm>
                <a:off x="456516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8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"/>
              <p:cNvSpPr/>
              <p:nvPr/>
            </p:nvSpPr>
            <p:spPr>
              <a:xfrm>
                <a:off x="4919040" y="3330720"/>
                <a:ext cx="2566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>
                <a:off x="3082680" y="3578400"/>
                <a:ext cx="470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Length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"/>
              <p:cNvSpPr/>
              <p:nvPr/>
            </p:nvSpPr>
            <p:spPr>
              <a:xfrm rot="16200000">
                <a:off x="648720" y="2043720"/>
                <a:ext cx="723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requency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"/>
              <p:cNvSpPr/>
              <p:nvPr/>
            </p:nvSpPr>
            <p:spPr>
              <a:xfrm>
                <a:off x="3830760" y="1209600"/>
                <a:ext cx="1207800" cy="468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3876840" y="1289160"/>
                <a:ext cx="88560" cy="91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"/>
              <p:cNvSpPr/>
              <p:nvPr/>
            </p:nvSpPr>
            <p:spPr>
              <a:xfrm>
                <a:off x="4043520" y="1249200"/>
                <a:ext cx="834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Full data se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"/>
              <p:cNvSpPr/>
              <p:nvPr/>
            </p:nvSpPr>
            <p:spPr>
              <a:xfrm>
                <a:off x="3876840" y="1517760"/>
                <a:ext cx="88560" cy="90360"/>
              </a:xfrm>
              <a:prstGeom prst="rect">
                <a:avLst/>
              </a:prstGeom>
              <a:solidFill>
                <a:srgbClr val="0000ff"/>
              </a:solidFill>
              <a:ln w="9360">
                <a:solidFill>
                  <a:srgbClr val="00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"/>
              <p:cNvSpPr/>
              <p:nvPr/>
            </p:nvSpPr>
            <p:spPr>
              <a:xfrm>
                <a:off x="4043880" y="1477800"/>
                <a:ext cx="1079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Clone correc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"/>
              <p:cNvSpPr/>
              <p:nvPr/>
            </p:nvSpPr>
            <p:spPr>
              <a:xfrm>
                <a:off x="1901160" y="1897200"/>
                <a:ext cx="55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bserv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1902960" y="2050920"/>
                <a:ext cx="680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full data set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1902600" y="2203560"/>
                <a:ext cx="319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= 10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1600920" y="1293840"/>
                <a:ext cx="55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bserv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1601640" y="1446120"/>
                <a:ext cx="9014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lone correct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1601280" y="1598760"/>
                <a:ext cx="803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data set = 10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1585800" y="1774800"/>
                <a:ext cx="76320" cy="1351080"/>
              </a:xfrm>
              <a:custGeom>
                <a:avLst/>
                <a:gdLst/>
                <a:ahLst/>
                <a:rect l="l" t="t" r="r" b="b"/>
                <a:pathLst>
                  <a:path w="96" h="1702">
                    <a:moveTo>
                      <a:pt x="56" y="8"/>
                    </a:moveTo>
                    <a:lnTo>
                      <a:pt x="56" y="1622"/>
                    </a:lnTo>
                    <a:lnTo>
                      <a:pt x="56" y="1626"/>
                    </a:lnTo>
                    <a:lnTo>
                      <a:pt x="54" y="1628"/>
                    </a:lnTo>
                    <a:lnTo>
                      <a:pt x="52" y="1629"/>
                    </a:lnTo>
                    <a:lnTo>
                      <a:pt x="48" y="1629"/>
                    </a:lnTo>
                    <a:lnTo>
                      <a:pt x="46" y="1629"/>
                    </a:lnTo>
                    <a:lnTo>
                      <a:pt x="42" y="1628"/>
                    </a:lnTo>
                    <a:lnTo>
                      <a:pt x="40" y="1626"/>
                    </a:lnTo>
                    <a:lnTo>
                      <a:pt x="40" y="1622"/>
                    </a:lnTo>
                    <a:lnTo>
                      <a:pt x="40" y="8"/>
                    </a:lnTo>
                    <a:lnTo>
                      <a:pt x="40" y="6"/>
                    </a:lnTo>
                    <a:lnTo>
                      <a:pt x="42" y="2"/>
                    </a:lnTo>
                    <a:lnTo>
                      <a:pt x="46" y="0"/>
                    </a:lnTo>
                    <a:lnTo>
                      <a:pt x="48" y="0"/>
                    </a:lnTo>
                    <a:lnTo>
                      <a:pt x="52" y="0"/>
                    </a:lnTo>
                    <a:lnTo>
                      <a:pt x="54" y="2"/>
                    </a:lnTo>
                    <a:lnTo>
                      <a:pt x="56" y="6"/>
                    </a:lnTo>
                    <a:lnTo>
                      <a:pt x="56" y="8"/>
                    </a:lnTo>
                    <a:lnTo>
                      <a:pt x="56" y="8"/>
                    </a:lnTo>
                    <a:close/>
                    <a:moveTo>
                      <a:pt x="96" y="1606"/>
                    </a:moveTo>
                    <a:lnTo>
                      <a:pt x="48" y="1702"/>
                    </a:lnTo>
                    <a:lnTo>
                      <a:pt x="0" y="1606"/>
                    </a:lnTo>
                    <a:lnTo>
                      <a:pt x="96" y="1606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1676520" y="2343240"/>
                <a:ext cx="284040" cy="806400"/>
              </a:xfrm>
              <a:custGeom>
                <a:avLst/>
                <a:gdLst/>
                <a:ahLst/>
                <a:rect l="l" t="t" r="r" b="b"/>
                <a:pathLst>
                  <a:path w="359" h="1016">
                    <a:moveTo>
                      <a:pt x="359" y="11"/>
                    </a:moveTo>
                    <a:lnTo>
                      <a:pt x="48" y="943"/>
                    </a:lnTo>
                    <a:lnTo>
                      <a:pt x="46" y="945"/>
                    </a:lnTo>
                    <a:lnTo>
                      <a:pt x="44" y="947"/>
                    </a:lnTo>
                    <a:lnTo>
                      <a:pt x="40" y="949"/>
                    </a:lnTo>
                    <a:lnTo>
                      <a:pt x="39" y="949"/>
                    </a:lnTo>
                    <a:lnTo>
                      <a:pt x="35" y="947"/>
                    </a:lnTo>
                    <a:lnTo>
                      <a:pt x="33" y="945"/>
                    </a:lnTo>
                    <a:lnTo>
                      <a:pt x="33" y="941"/>
                    </a:lnTo>
                    <a:lnTo>
                      <a:pt x="33" y="937"/>
                    </a:lnTo>
                    <a:lnTo>
                      <a:pt x="343" y="6"/>
                    </a:lnTo>
                    <a:lnTo>
                      <a:pt x="345" y="2"/>
                    </a:lnTo>
                    <a:lnTo>
                      <a:pt x="347" y="2"/>
                    </a:lnTo>
                    <a:lnTo>
                      <a:pt x="351" y="0"/>
                    </a:lnTo>
                    <a:lnTo>
                      <a:pt x="353" y="0"/>
                    </a:lnTo>
                    <a:lnTo>
                      <a:pt x="357" y="2"/>
                    </a:lnTo>
                    <a:lnTo>
                      <a:pt x="359" y="4"/>
                    </a:lnTo>
                    <a:lnTo>
                      <a:pt x="359" y="7"/>
                    </a:lnTo>
                    <a:lnTo>
                      <a:pt x="359" y="11"/>
                    </a:lnTo>
                    <a:lnTo>
                      <a:pt x="359" y="11"/>
                    </a:lnTo>
                    <a:close/>
                    <a:moveTo>
                      <a:pt x="90" y="941"/>
                    </a:moveTo>
                    <a:lnTo>
                      <a:pt x="16" y="1016"/>
                    </a:lnTo>
                    <a:lnTo>
                      <a:pt x="0" y="911"/>
                    </a:lnTo>
                    <a:lnTo>
                      <a:pt x="90" y="941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1888920" y="4100400"/>
                <a:ext cx="31813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Distribution of tree lengths for eastern Thailan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762120" y="4422600"/>
                <a:ext cx="4478040" cy="2880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1484280" y="4584600"/>
                <a:ext cx="3621240" cy="2040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1484280" y="4584600"/>
                <a:ext cx="3621240" cy="2040120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2300400" y="6615000"/>
                <a:ext cx="11412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7" name=""/>
              <p:cNvSpPr/>
              <p:nvPr/>
            </p:nvSpPr>
            <p:spPr>
              <a:xfrm>
                <a:off x="3005280" y="6605640"/>
                <a:ext cx="114120" cy="19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"/>
              <p:cNvSpPr/>
              <p:nvPr/>
            </p:nvSpPr>
            <p:spPr>
              <a:xfrm>
                <a:off x="3119400" y="6615000"/>
                <a:ext cx="11448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3233880" y="6576840"/>
                <a:ext cx="123840" cy="478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3357720" y="6472080"/>
                <a:ext cx="112680" cy="152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3470400" y="6195960"/>
                <a:ext cx="114120" cy="4287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"/>
              <p:cNvSpPr/>
              <p:nvPr/>
            </p:nvSpPr>
            <p:spPr>
              <a:xfrm>
                <a:off x="3584520" y="5977080"/>
                <a:ext cx="123840" cy="647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>
                <a:off x="3708360" y="5300640"/>
                <a:ext cx="114480" cy="1324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"/>
              <p:cNvSpPr/>
              <p:nvPr/>
            </p:nvSpPr>
            <p:spPr>
              <a:xfrm>
                <a:off x="3822840" y="5156280"/>
                <a:ext cx="114120" cy="1468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"/>
              <p:cNvSpPr/>
              <p:nvPr/>
            </p:nvSpPr>
            <p:spPr>
              <a:xfrm>
                <a:off x="3936960" y="4871880"/>
                <a:ext cx="112680" cy="17528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"/>
              <p:cNvSpPr/>
              <p:nvPr/>
            </p:nvSpPr>
            <p:spPr>
              <a:xfrm>
                <a:off x="4049640" y="5432400"/>
                <a:ext cx="123840" cy="1192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4173480" y="5938920"/>
                <a:ext cx="114480" cy="685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"/>
              <p:cNvSpPr/>
              <p:nvPr/>
            </p:nvSpPr>
            <p:spPr>
              <a:xfrm>
                <a:off x="4287960" y="6310440"/>
                <a:ext cx="114120" cy="314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"/>
              <p:cNvSpPr/>
              <p:nvPr/>
            </p:nvSpPr>
            <p:spPr>
              <a:xfrm>
                <a:off x="4402080" y="6529320"/>
                <a:ext cx="122400" cy="954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"/>
              <p:cNvSpPr/>
              <p:nvPr/>
            </p:nvSpPr>
            <p:spPr>
              <a:xfrm>
                <a:off x="4524480" y="6615000"/>
                <a:ext cx="11412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2300400" y="6605640"/>
                <a:ext cx="114120" cy="190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"/>
              <p:cNvSpPr/>
              <p:nvPr/>
            </p:nvSpPr>
            <p:spPr>
              <a:xfrm>
                <a:off x="2414520" y="6576840"/>
                <a:ext cx="125640" cy="47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"/>
              <p:cNvSpPr/>
              <p:nvPr/>
            </p:nvSpPr>
            <p:spPr>
              <a:xfrm>
                <a:off x="2540160" y="6462720"/>
                <a:ext cx="112680" cy="1620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4" name=""/>
              <p:cNvSpPr/>
              <p:nvPr/>
            </p:nvSpPr>
            <p:spPr>
              <a:xfrm>
                <a:off x="2652840" y="6356520"/>
                <a:ext cx="114120" cy="2682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>
                <a:off x="2766960" y="5919840"/>
                <a:ext cx="114480" cy="704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6" name=""/>
              <p:cNvSpPr/>
              <p:nvPr/>
            </p:nvSpPr>
            <p:spPr>
              <a:xfrm>
                <a:off x="2881440" y="5386320"/>
                <a:ext cx="123840" cy="12384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7" name=""/>
              <p:cNvSpPr/>
              <p:nvPr/>
            </p:nvSpPr>
            <p:spPr>
              <a:xfrm>
                <a:off x="3005280" y="4965840"/>
                <a:ext cx="114120" cy="1658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3119400" y="4976640"/>
                <a:ext cx="114480" cy="16480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9" name=""/>
              <p:cNvSpPr/>
              <p:nvPr/>
            </p:nvSpPr>
            <p:spPr>
              <a:xfrm>
                <a:off x="3233880" y="5176800"/>
                <a:ext cx="123840" cy="14479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0" name=""/>
              <p:cNvSpPr/>
              <p:nvPr/>
            </p:nvSpPr>
            <p:spPr>
              <a:xfrm>
                <a:off x="3357720" y="5958000"/>
                <a:ext cx="112680" cy="6667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1" name=""/>
              <p:cNvSpPr/>
              <p:nvPr/>
            </p:nvSpPr>
            <p:spPr>
              <a:xfrm>
                <a:off x="3470400" y="6386400"/>
                <a:ext cx="114120" cy="2383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2" name=""/>
              <p:cNvSpPr/>
              <p:nvPr/>
            </p:nvSpPr>
            <p:spPr>
              <a:xfrm>
                <a:off x="3584520" y="6576840"/>
                <a:ext cx="123840" cy="47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3" name=""/>
              <p:cNvSpPr/>
              <p:nvPr/>
            </p:nvSpPr>
            <p:spPr>
              <a:xfrm>
                <a:off x="3708360" y="6615000"/>
                <a:ext cx="114480" cy="97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4" name=""/>
              <p:cNvSpPr/>
              <p:nvPr/>
            </p:nvSpPr>
            <p:spPr>
              <a:xfrm>
                <a:off x="1484280" y="4584600"/>
                <a:ext cx="1800" cy="2040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"/>
              <p:cNvSpPr/>
              <p:nvPr/>
            </p:nvSpPr>
            <p:spPr>
              <a:xfrm>
                <a:off x="1436760" y="662472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"/>
              <p:cNvSpPr/>
              <p:nvPr/>
            </p:nvSpPr>
            <p:spPr>
              <a:xfrm>
                <a:off x="1436760" y="621504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"/>
              <p:cNvSpPr/>
              <p:nvPr/>
            </p:nvSpPr>
            <p:spPr>
              <a:xfrm>
                <a:off x="1436760" y="580536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"/>
              <p:cNvSpPr/>
              <p:nvPr/>
            </p:nvSpPr>
            <p:spPr>
              <a:xfrm>
                <a:off x="1436760" y="540540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"/>
              <p:cNvSpPr/>
              <p:nvPr/>
            </p:nvSpPr>
            <p:spPr>
              <a:xfrm>
                <a:off x="1436760" y="499572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"/>
              <p:cNvSpPr/>
              <p:nvPr/>
            </p:nvSpPr>
            <p:spPr>
              <a:xfrm>
                <a:off x="1436760" y="458460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>
                <a:off x="1484280" y="6624720"/>
                <a:ext cx="3621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"/>
              <p:cNvSpPr/>
              <p:nvPr/>
            </p:nvSpPr>
            <p:spPr>
              <a:xfrm flipV="1">
                <a:off x="1484280" y="6624720"/>
                <a:ext cx="180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3" name=""/>
              <p:cNvSpPr/>
              <p:nvPr/>
            </p:nvSpPr>
            <p:spPr>
              <a:xfrm flipV="1">
                <a:off x="3822840" y="6624720"/>
                <a:ext cx="144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>
                <a:off x="1330560" y="654840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5" name=""/>
              <p:cNvSpPr/>
              <p:nvPr/>
            </p:nvSpPr>
            <p:spPr>
              <a:xfrm>
                <a:off x="1257480" y="61387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1185480" y="572940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7" name=""/>
              <p:cNvSpPr/>
              <p:nvPr/>
            </p:nvSpPr>
            <p:spPr>
              <a:xfrm>
                <a:off x="1185480" y="532908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5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>
                <a:off x="1185480" y="491976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9" name=""/>
              <p:cNvSpPr/>
              <p:nvPr/>
            </p:nvSpPr>
            <p:spPr>
              <a:xfrm>
                <a:off x="1185480" y="450864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25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0" name=""/>
              <p:cNvSpPr/>
              <p:nvPr/>
            </p:nvSpPr>
            <p:spPr>
              <a:xfrm>
                <a:off x="150516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7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1" name=""/>
              <p:cNvSpPr/>
              <p:nvPr/>
            </p:nvSpPr>
            <p:spPr>
              <a:xfrm>
                <a:off x="209412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7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>
                <a:off x="267372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8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3" name=""/>
              <p:cNvSpPr/>
              <p:nvPr/>
            </p:nvSpPr>
            <p:spPr>
              <a:xfrm>
                <a:off x="326268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8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4" name=""/>
              <p:cNvSpPr/>
              <p:nvPr/>
            </p:nvSpPr>
            <p:spPr>
              <a:xfrm>
                <a:off x="384192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9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"/>
              <p:cNvSpPr/>
              <p:nvPr/>
            </p:nvSpPr>
            <p:spPr>
              <a:xfrm>
                <a:off x="4422960" y="67579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95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>
                <a:off x="4978080" y="675792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"/>
              <p:cNvSpPr/>
              <p:nvPr/>
            </p:nvSpPr>
            <p:spPr>
              <a:xfrm>
                <a:off x="3133440" y="6996240"/>
                <a:ext cx="4291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Length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8" name=""/>
              <p:cNvSpPr/>
              <p:nvPr/>
            </p:nvSpPr>
            <p:spPr>
              <a:xfrm rot="16200000">
                <a:off x="663840" y="5462280"/>
                <a:ext cx="6620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Frequency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9" name=""/>
              <p:cNvSpPr/>
              <p:nvPr/>
            </p:nvSpPr>
            <p:spPr>
              <a:xfrm>
                <a:off x="4030560" y="4491000"/>
                <a:ext cx="1209600" cy="449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4079880" y="4567320"/>
                <a:ext cx="85680" cy="856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880" bIns="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1" name=""/>
              <p:cNvSpPr/>
              <p:nvPr/>
            </p:nvSpPr>
            <p:spPr>
              <a:xfrm>
                <a:off x="4278600" y="4529160"/>
                <a:ext cx="7642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Full data set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"/>
              <p:cNvSpPr/>
              <p:nvPr/>
            </p:nvSpPr>
            <p:spPr>
              <a:xfrm>
                <a:off x="4079880" y="4786200"/>
                <a:ext cx="95400" cy="954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"/>
              <p:cNvSpPr/>
              <p:nvPr/>
            </p:nvSpPr>
            <p:spPr>
              <a:xfrm>
                <a:off x="4289040" y="4748040"/>
                <a:ext cx="9896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Clone corrected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"/>
              <p:cNvSpPr/>
              <p:nvPr/>
            </p:nvSpPr>
            <p:spPr>
              <a:xfrm>
                <a:off x="2449440" y="5160960"/>
                <a:ext cx="125640" cy="1360440"/>
              </a:xfrm>
              <a:custGeom>
                <a:avLst/>
                <a:gdLst/>
                <a:ahLst/>
                <a:rect l="l" t="t" r="r" b="b"/>
                <a:pathLst>
                  <a:path w="157" h="1714">
                    <a:moveTo>
                      <a:pt x="157" y="9"/>
                    </a:moveTo>
                    <a:lnTo>
                      <a:pt x="55" y="1635"/>
                    </a:lnTo>
                    <a:lnTo>
                      <a:pt x="53" y="1637"/>
                    </a:lnTo>
                    <a:lnTo>
                      <a:pt x="51" y="1639"/>
                    </a:lnTo>
                    <a:lnTo>
                      <a:pt x="50" y="1640"/>
                    </a:lnTo>
                    <a:lnTo>
                      <a:pt x="46" y="1640"/>
                    </a:lnTo>
                    <a:lnTo>
                      <a:pt x="44" y="1640"/>
                    </a:lnTo>
                    <a:lnTo>
                      <a:pt x="40" y="1639"/>
                    </a:lnTo>
                    <a:lnTo>
                      <a:pt x="40" y="1637"/>
                    </a:lnTo>
                    <a:lnTo>
                      <a:pt x="38" y="1633"/>
                    </a:lnTo>
                    <a:lnTo>
                      <a:pt x="142" y="7"/>
                    </a:lnTo>
                    <a:lnTo>
                      <a:pt x="142" y="3"/>
                    </a:lnTo>
                    <a:lnTo>
                      <a:pt x="143" y="2"/>
                    </a:lnTo>
                    <a:lnTo>
                      <a:pt x="147" y="0"/>
                    </a:lnTo>
                    <a:lnTo>
                      <a:pt x="151" y="0"/>
                    </a:lnTo>
                    <a:lnTo>
                      <a:pt x="153" y="2"/>
                    </a:lnTo>
                    <a:lnTo>
                      <a:pt x="155" y="3"/>
                    </a:lnTo>
                    <a:lnTo>
                      <a:pt x="157" y="5"/>
                    </a:lnTo>
                    <a:lnTo>
                      <a:pt x="157" y="9"/>
                    </a:lnTo>
                    <a:lnTo>
                      <a:pt x="157" y="9"/>
                    </a:lnTo>
                    <a:close/>
                    <a:moveTo>
                      <a:pt x="96" y="1621"/>
                    </a:moveTo>
                    <a:lnTo>
                      <a:pt x="42" y="1714"/>
                    </a:lnTo>
                    <a:lnTo>
                      <a:pt x="0" y="1614"/>
                    </a:lnTo>
                    <a:lnTo>
                      <a:pt x="96" y="1621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>
                <a:off x="2127960" y="4691160"/>
                <a:ext cx="55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bserv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6" name=""/>
              <p:cNvSpPr/>
              <p:nvPr/>
            </p:nvSpPr>
            <p:spPr>
              <a:xfrm>
                <a:off x="2128680" y="4843440"/>
                <a:ext cx="9014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lone correct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7" name=""/>
              <p:cNvSpPr/>
              <p:nvPr/>
            </p:nvSpPr>
            <p:spPr>
              <a:xfrm>
                <a:off x="2128680" y="4995720"/>
                <a:ext cx="733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data set = 7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8" name=""/>
              <p:cNvSpPr/>
              <p:nvPr/>
            </p:nvSpPr>
            <p:spPr>
              <a:xfrm>
                <a:off x="1696320" y="5342040"/>
                <a:ext cx="556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observed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9" name=""/>
              <p:cNvSpPr/>
              <p:nvPr/>
            </p:nvSpPr>
            <p:spPr>
              <a:xfrm>
                <a:off x="1698120" y="5494320"/>
                <a:ext cx="680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full data set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0" name=""/>
              <p:cNvSpPr/>
              <p:nvPr/>
            </p:nvSpPr>
            <p:spPr>
              <a:xfrm>
                <a:off x="1697760" y="5646600"/>
                <a:ext cx="249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= 7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1" name=""/>
              <p:cNvSpPr/>
              <p:nvPr/>
            </p:nvSpPr>
            <p:spPr>
              <a:xfrm>
                <a:off x="2027160" y="5815080"/>
                <a:ext cx="335160" cy="750960"/>
              </a:xfrm>
              <a:custGeom>
                <a:avLst/>
                <a:gdLst/>
                <a:ahLst/>
                <a:rect l="l" t="t" r="r" b="b"/>
                <a:pathLst>
                  <a:path w="422" h="945">
                    <a:moveTo>
                      <a:pt x="15" y="6"/>
                    </a:moveTo>
                    <a:lnTo>
                      <a:pt x="391" y="868"/>
                    </a:lnTo>
                    <a:lnTo>
                      <a:pt x="391" y="872"/>
                    </a:lnTo>
                    <a:lnTo>
                      <a:pt x="391" y="874"/>
                    </a:lnTo>
                    <a:lnTo>
                      <a:pt x="389" y="878"/>
                    </a:lnTo>
                    <a:lnTo>
                      <a:pt x="387" y="880"/>
                    </a:lnTo>
                    <a:lnTo>
                      <a:pt x="383" y="880"/>
                    </a:lnTo>
                    <a:lnTo>
                      <a:pt x="379" y="880"/>
                    </a:lnTo>
                    <a:lnTo>
                      <a:pt x="377" y="878"/>
                    </a:lnTo>
                    <a:lnTo>
                      <a:pt x="376" y="874"/>
                    </a:lnTo>
                    <a:lnTo>
                      <a:pt x="0" y="11"/>
                    </a:lnTo>
                    <a:lnTo>
                      <a:pt x="0" y="8"/>
                    </a:lnTo>
                    <a:lnTo>
                      <a:pt x="0" y="6"/>
                    </a:lnTo>
                    <a:lnTo>
                      <a:pt x="2" y="4"/>
                    </a:lnTo>
                    <a:lnTo>
                      <a:pt x="4" y="2"/>
                    </a:lnTo>
                    <a:lnTo>
                      <a:pt x="8" y="0"/>
                    </a:lnTo>
                    <a:lnTo>
                      <a:pt x="11" y="2"/>
                    </a:lnTo>
                    <a:lnTo>
                      <a:pt x="13" y="2"/>
                    </a:lnTo>
                    <a:lnTo>
                      <a:pt x="15" y="6"/>
                    </a:lnTo>
                    <a:lnTo>
                      <a:pt x="15" y="6"/>
                    </a:lnTo>
                    <a:close/>
                    <a:moveTo>
                      <a:pt x="422" y="838"/>
                    </a:moveTo>
                    <a:lnTo>
                      <a:pt x="416" y="945"/>
                    </a:lnTo>
                    <a:lnTo>
                      <a:pt x="333" y="876"/>
                    </a:lnTo>
                    <a:lnTo>
                      <a:pt x="422" y="838"/>
                    </a:lnTo>
                    <a:close/>
                  </a:path>
                </a:pathLst>
              </a:custGeom>
              <a:solidFill>
                <a:srgbClr val="000000"/>
              </a:solidFill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2" name=""/>
              <p:cNvSpPr/>
              <p:nvPr/>
            </p:nvSpPr>
            <p:spPr>
              <a:xfrm>
                <a:off x="4046400" y="4503600"/>
                <a:ext cx="1273320" cy="4114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3" name=""/>
              <p:cNvSpPr/>
              <p:nvPr/>
            </p:nvSpPr>
            <p:spPr>
              <a:xfrm>
                <a:off x="4046400" y="4503600"/>
                <a:ext cx="1273320" cy="411480"/>
              </a:xfrm>
              <a:prstGeom prst="rect">
                <a:avLst/>
              </a:prstGeom>
              <a:noFill/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4" name=""/>
              <p:cNvSpPr/>
              <p:nvPr/>
            </p:nvSpPr>
            <p:spPr>
              <a:xfrm>
                <a:off x="762120" y="4422600"/>
                <a:ext cx="4478040" cy="28800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5" name=""/>
              <p:cNvSpPr/>
              <p:nvPr/>
            </p:nvSpPr>
            <p:spPr>
              <a:xfrm>
                <a:off x="1484280" y="4584600"/>
                <a:ext cx="3621240" cy="2040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6" name=""/>
              <p:cNvSpPr/>
              <p:nvPr/>
            </p:nvSpPr>
            <p:spPr>
              <a:xfrm>
                <a:off x="1484280" y="4584600"/>
                <a:ext cx="3621240" cy="2040120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7" name=""/>
              <p:cNvSpPr/>
              <p:nvPr/>
            </p:nvSpPr>
            <p:spPr>
              <a:xfrm>
                <a:off x="2300400" y="6615000"/>
                <a:ext cx="11412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8" name=""/>
              <p:cNvSpPr/>
              <p:nvPr/>
            </p:nvSpPr>
            <p:spPr>
              <a:xfrm>
                <a:off x="3005280" y="6605640"/>
                <a:ext cx="114120" cy="19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09" name=""/>
              <p:cNvSpPr/>
              <p:nvPr/>
            </p:nvSpPr>
            <p:spPr>
              <a:xfrm>
                <a:off x="3119400" y="6615000"/>
                <a:ext cx="11448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"/>
              <p:cNvSpPr/>
              <p:nvPr/>
            </p:nvSpPr>
            <p:spPr>
              <a:xfrm>
                <a:off x="3233880" y="6576840"/>
                <a:ext cx="123840" cy="478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"/>
              <p:cNvSpPr/>
              <p:nvPr/>
            </p:nvSpPr>
            <p:spPr>
              <a:xfrm>
                <a:off x="3357720" y="6472080"/>
                <a:ext cx="112680" cy="152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"/>
              <p:cNvSpPr/>
              <p:nvPr/>
            </p:nvSpPr>
            <p:spPr>
              <a:xfrm>
                <a:off x="3470400" y="6195960"/>
                <a:ext cx="114120" cy="42876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"/>
              <p:cNvSpPr/>
              <p:nvPr/>
            </p:nvSpPr>
            <p:spPr>
              <a:xfrm>
                <a:off x="3584520" y="5977080"/>
                <a:ext cx="123840" cy="647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"/>
              <p:cNvSpPr/>
              <p:nvPr/>
            </p:nvSpPr>
            <p:spPr>
              <a:xfrm>
                <a:off x="3708360" y="5300640"/>
                <a:ext cx="114480" cy="13240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"/>
              <p:cNvSpPr/>
              <p:nvPr/>
            </p:nvSpPr>
            <p:spPr>
              <a:xfrm>
                <a:off x="3822840" y="5156280"/>
                <a:ext cx="114120" cy="1468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"/>
              <p:cNvSpPr/>
              <p:nvPr/>
            </p:nvSpPr>
            <p:spPr>
              <a:xfrm>
                <a:off x="3936960" y="4871880"/>
                <a:ext cx="112680" cy="17528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7" name=""/>
              <p:cNvSpPr/>
              <p:nvPr/>
            </p:nvSpPr>
            <p:spPr>
              <a:xfrm>
                <a:off x="4049640" y="5432400"/>
                <a:ext cx="123840" cy="11923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8" name=""/>
              <p:cNvSpPr/>
              <p:nvPr/>
            </p:nvSpPr>
            <p:spPr>
              <a:xfrm>
                <a:off x="4173480" y="5938920"/>
                <a:ext cx="114480" cy="6858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9" name=""/>
              <p:cNvSpPr/>
              <p:nvPr/>
            </p:nvSpPr>
            <p:spPr>
              <a:xfrm>
                <a:off x="4287960" y="6310440"/>
                <a:ext cx="114120" cy="3142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"/>
              <p:cNvSpPr/>
              <p:nvPr/>
            </p:nvSpPr>
            <p:spPr>
              <a:xfrm>
                <a:off x="4402080" y="6529320"/>
                <a:ext cx="122400" cy="9540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"/>
              <p:cNvSpPr/>
              <p:nvPr/>
            </p:nvSpPr>
            <p:spPr>
              <a:xfrm>
                <a:off x="4524480" y="6615000"/>
                <a:ext cx="114120" cy="97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2" name=""/>
              <p:cNvSpPr/>
              <p:nvPr/>
            </p:nvSpPr>
            <p:spPr>
              <a:xfrm>
                <a:off x="2300400" y="6605640"/>
                <a:ext cx="114120" cy="190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"/>
              <p:cNvSpPr/>
              <p:nvPr/>
            </p:nvSpPr>
            <p:spPr>
              <a:xfrm>
                <a:off x="2414520" y="6576840"/>
                <a:ext cx="125640" cy="47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"/>
              <p:cNvSpPr/>
              <p:nvPr/>
            </p:nvSpPr>
            <p:spPr>
              <a:xfrm>
                <a:off x="2540160" y="6462720"/>
                <a:ext cx="112680" cy="1620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"/>
              <p:cNvSpPr/>
              <p:nvPr/>
            </p:nvSpPr>
            <p:spPr>
              <a:xfrm>
                <a:off x="2652840" y="6356520"/>
                <a:ext cx="114120" cy="2682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"/>
              <p:cNvSpPr/>
              <p:nvPr/>
            </p:nvSpPr>
            <p:spPr>
              <a:xfrm>
                <a:off x="2766960" y="5919840"/>
                <a:ext cx="114480" cy="704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"/>
              <p:cNvSpPr/>
              <p:nvPr/>
            </p:nvSpPr>
            <p:spPr>
              <a:xfrm>
                <a:off x="2881440" y="5386320"/>
                <a:ext cx="123840" cy="12384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"/>
              <p:cNvSpPr/>
              <p:nvPr/>
            </p:nvSpPr>
            <p:spPr>
              <a:xfrm>
                <a:off x="3005280" y="4965840"/>
                <a:ext cx="114120" cy="1658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9" name=""/>
              <p:cNvSpPr/>
              <p:nvPr/>
            </p:nvSpPr>
            <p:spPr>
              <a:xfrm>
                <a:off x="3119400" y="4976640"/>
                <a:ext cx="114480" cy="16480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0" name=""/>
              <p:cNvSpPr/>
              <p:nvPr/>
            </p:nvSpPr>
            <p:spPr>
              <a:xfrm>
                <a:off x="3233880" y="5176800"/>
                <a:ext cx="123840" cy="14479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"/>
              <p:cNvSpPr/>
              <p:nvPr/>
            </p:nvSpPr>
            <p:spPr>
              <a:xfrm>
                <a:off x="3357720" y="5958000"/>
                <a:ext cx="112680" cy="6667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"/>
              <p:cNvSpPr/>
              <p:nvPr/>
            </p:nvSpPr>
            <p:spPr>
              <a:xfrm>
                <a:off x="3470400" y="6386400"/>
                <a:ext cx="114120" cy="2383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3" name=""/>
              <p:cNvSpPr/>
              <p:nvPr/>
            </p:nvSpPr>
            <p:spPr>
              <a:xfrm>
                <a:off x="3584520" y="6576840"/>
                <a:ext cx="123840" cy="478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4" name=""/>
              <p:cNvSpPr/>
              <p:nvPr/>
            </p:nvSpPr>
            <p:spPr>
              <a:xfrm>
                <a:off x="3708360" y="6615000"/>
                <a:ext cx="114480" cy="972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080" bIns="-37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"/>
              <p:cNvSpPr/>
              <p:nvPr/>
            </p:nvSpPr>
            <p:spPr>
              <a:xfrm>
                <a:off x="1484280" y="4584600"/>
                <a:ext cx="1800" cy="2040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"/>
              <p:cNvSpPr/>
              <p:nvPr/>
            </p:nvSpPr>
            <p:spPr>
              <a:xfrm>
                <a:off x="1436760" y="662472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7" name=""/>
              <p:cNvSpPr/>
              <p:nvPr/>
            </p:nvSpPr>
            <p:spPr>
              <a:xfrm>
                <a:off x="1436760" y="6215040"/>
                <a:ext cx="475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8" name=""/>
              <p:cNvSpPr/>
              <p:nvPr/>
            </p:nvSpPr>
            <p:spPr>
              <a:xfrm>
                <a:off x="1436760" y="580536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9" name=""/>
              <p:cNvSpPr/>
              <p:nvPr/>
            </p:nvSpPr>
            <p:spPr>
              <a:xfrm>
                <a:off x="1436760" y="540540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"/>
              <p:cNvSpPr/>
              <p:nvPr/>
            </p:nvSpPr>
            <p:spPr>
              <a:xfrm>
                <a:off x="1436760" y="499572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"/>
              <p:cNvSpPr/>
              <p:nvPr/>
            </p:nvSpPr>
            <p:spPr>
              <a:xfrm>
                <a:off x="1436760" y="4584600"/>
                <a:ext cx="475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2" name=""/>
              <p:cNvSpPr/>
              <p:nvPr/>
            </p:nvSpPr>
            <p:spPr>
              <a:xfrm>
                <a:off x="1484280" y="6624720"/>
                <a:ext cx="3621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3" name=""/>
              <p:cNvSpPr/>
              <p:nvPr/>
            </p:nvSpPr>
            <p:spPr>
              <a:xfrm flipV="1">
                <a:off x="1484280" y="6624720"/>
                <a:ext cx="180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"/>
              <p:cNvSpPr/>
              <p:nvPr/>
            </p:nvSpPr>
            <p:spPr>
              <a:xfrm flipV="1">
                <a:off x="3822840" y="6624720"/>
                <a:ext cx="1440" cy="47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45" name=""/>
            <p:cNvSpPr/>
            <p:nvPr/>
          </p:nvSpPr>
          <p:spPr>
            <a:xfrm>
              <a:off x="1330560" y="654840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1257480" y="61387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1185480" y="572940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1185480" y="532908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1185480" y="491976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1185480" y="450864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"/>
            <p:cNvSpPr/>
            <p:nvPr/>
          </p:nvSpPr>
          <p:spPr>
            <a:xfrm>
              <a:off x="1505160" y="67579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"/>
            <p:cNvSpPr/>
            <p:nvPr/>
          </p:nvSpPr>
          <p:spPr>
            <a:xfrm>
              <a:off x="2094120" y="67579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7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"/>
            <p:cNvSpPr/>
            <p:nvPr/>
          </p:nvSpPr>
          <p:spPr>
            <a:xfrm>
              <a:off x="2673720" y="67579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"/>
            <p:cNvSpPr/>
            <p:nvPr/>
          </p:nvSpPr>
          <p:spPr>
            <a:xfrm>
              <a:off x="3262680" y="67579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8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"/>
            <p:cNvSpPr/>
            <p:nvPr/>
          </p:nvSpPr>
          <p:spPr>
            <a:xfrm>
              <a:off x="3841920" y="67579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9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"/>
            <p:cNvSpPr/>
            <p:nvPr/>
          </p:nvSpPr>
          <p:spPr>
            <a:xfrm>
              <a:off x="4422960" y="675792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9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"/>
            <p:cNvSpPr/>
            <p:nvPr/>
          </p:nvSpPr>
          <p:spPr>
            <a:xfrm>
              <a:off x="4978080" y="675792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"/>
            <p:cNvSpPr/>
            <p:nvPr/>
          </p:nvSpPr>
          <p:spPr>
            <a:xfrm>
              <a:off x="3133440" y="6996240"/>
              <a:ext cx="4291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ength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"/>
            <p:cNvSpPr/>
            <p:nvPr/>
          </p:nvSpPr>
          <p:spPr>
            <a:xfrm rot="16200000">
              <a:off x="663840" y="5462280"/>
              <a:ext cx="6620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Frequency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"/>
            <p:cNvSpPr/>
            <p:nvPr/>
          </p:nvSpPr>
          <p:spPr>
            <a:xfrm>
              <a:off x="4030560" y="4491000"/>
              <a:ext cx="1209600" cy="449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"/>
            <p:cNvSpPr/>
            <p:nvPr/>
          </p:nvSpPr>
          <p:spPr>
            <a:xfrm>
              <a:off x="4079880" y="4567320"/>
              <a:ext cx="85680" cy="8568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"/>
            <p:cNvSpPr/>
            <p:nvPr/>
          </p:nvSpPr>
          <p:spPr>
            <a:xfrm>
              <a:off x="4278600" y="4529160"/>
              <a:ext cx="7642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Full data set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"/>
            <p:cNvSpPr/>
            <p:nvPr/>
          </p:nvSpPr>
          <p:spPr>
            <a:xfrm>
              <a:off x="4079880" y="4786200"/>
              <a:ext cx="95400" cy="954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"/>
            <p:cNvSpPr/>
            <p:nvPr/>
          </p:nvSpPr>
          <p:spPr>
            <a:xfrm>
              <a:off x="4289040" y="4748040"/>
              <a:ext cx="989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lone corrected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"/>
            <p:cNvSpPr/>
            <p:nvPr/>
          </p:nvSpPr>
          <p:spPr>
            <a:xfrm>
              <a:off x="2449440" y="5160960"/>
              <a:ext cx="125640" cy="1360440"/>
            </a:xfrm>
            <a:custGeom>
              <a:avLst/>
              <a:gdLst/>
              <a:ahLst/>
              <a:rect l="l" t="t" r="r" b="b"/>
              <a:pathLst>
                <a:path w="157" h="1714">
                  <a:moveTo>
                    <a:pt x="157" y="9"/>
                  </a:moveTo>
                  <a:lnTo>
                    <a:pt x="55" y="1635"/>
                  </a:lnTo>
                  <a:lnTo>
                    <a:pt x="53" y="1637"/>
                  </a:lnTo>
                  <a:lnTo>
                    <a:pt x="51" y="1639"/>
                  </a:lnTo>
                  <a:lnTo>
                    <a:pt x="50" y="1640"/>
                  </a:lnTo>
                  <a:lnTo>
                    <a:pt x="46" y="1640"/>
                  </a:lnTo>
                  <a:lnTo>
                    <a:pt x="44" y="1640"/>
                  </a:lnTo>
                  <a:lnTo>
                    <a:pt x="40" y="1639"/>
                  </a:lnTo>
                  <a:lnTo>
                    <a:pt x="40" y="1637"/>
                  </a:lnTo>
                  <a:lnTo>
                    <a:pt x="38" y="1633"/>
                  </a:lnTo>
                  <a:lnTo>
                    <a:pt x="142" y="7"/>
                  </a:lnTo>
                  <a:lnTo>
                    <a:pt x="142" y="3"/>
                  </a:lnTo>
                  <a:lnTo>
                    <a:pt x="143" y="2"/>
                  </a:lnTo>
                  <a:lnTo>
                    <a:pt x="147" y="0"/>
                  </a:lnTo>
                  <a:lnTo>
                    <a:pt x="151" y="0"/>
                  </a:lnTo>
                  <a:lnTo>
                    <a:pt x="153" y="2"/>
                  </a:lnTo>
                  <a:lnTo>
                    <a:pt x="155" y="3"/>
                  </a:lnTo>
                  <a:lnTo>
                    <a:pt x="157" y="5"/>
                  </a:lnTo>
                  <a:lnTo>
                    <a:pt x="157" y="9"/>
                  </a:lnTo>
                  <a:lnTo>
                    <a:pt x="157" y="9"/>
                  </a:lnTo>
                  <a:close/>
                  <a:moveTo>
                    <a:pt x="96" y="1621"/>
                  </a:moveTo>
                  <a:lnTo>
                    <a:pt x="42" y="1714"/>
                  </a:lnTo>
                  <a:lnTo>
                    <a:pt x="0" y="1614"/>
                  </a:lnTo>
                  <a:lnTo>
                    <a:pt x="96" y="1621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2127960" y="4691160"/>
              <a:ext cx="55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observed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2128680" y="4843440"/>
              <a:ext cx="901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lone corrected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2128680" y="4995720"/>
              <a:ext cx="733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data set = 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1696320" y="5342040"/>
              <a:ext cx="55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observed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1698120" y="5494320"/>
              <a:ext cx="680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ull data set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1697760" y="5646600"/>
              <a:ext cx="249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= 7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2027160" y="5815080"/>
              <a:ext cx="335160" cy="750960"/>
            </a:xfrm>
            <a:custGeom>
              <a:avLst/>
              <a:gdLst/>
              <a:ahLst/>
              <a:rect l="l" t="t" r="r" b="b"/>
              <a:pathLst>
                <a:path w="422" h="945">
                  <a:moveTo>
                    <a:pt x="15" y="6"/>
                  </a:moveTo>
                  <a:lnTo>
                    <a:pt x="391" y="868"/>
                  </a:lnTo>
                  <a:lnTo>
                    <a:pt x="391" y="872"/>
                  </a:lnTo>
                  <a:lnTo>
                    <a:pt x="391" y="874"/>
                  </a:lnTo>
                  <a:lnTo>
                    <a:pt x="389" y="878"/>
                  </a:lnTo>
                  <a:lnTo>
                    <a:pt x="387" y="880"/>
                  </a:lnTo>
                  <a:lnTo>
                    <a:pt x="383" y="880"/>
                  </a:lnTo>
                  <a:lnTo>
                    <a:pt x="379" y="880"/>
                  </a:lnTo>
                  <a:lnTo>
                    <a:pt x="377" y="878"/>
                  </a:lnTo>
                  <a:lnTo>
                    <a:pt x="376" y="874"/>
                  </a:lnTo>
                  <a:lnTo>
                    <a:pt x="0" y="11"/>
                  </a:lnTo>
                  <a:lnTo>
                    <a:pt x="0" y="8"/>
                  </a:lnTo>
                  <a:lnTo>
                    <a:pt x="0" y="6"/>
                  </a:lnTo>
                  <a:lnTo>
                    <a:pt x="2" y="4"/>
                  </a:lnTo>
                  <a:lnTo>
                    <a:pt x="4" y="2"/>
                  </a:lnTo>
                  <a:lnTo>
                    <a:pt x="8" y="0"/>
                  </a:lnTo>
                  <a:lnTo>
                    <a:pt x="11" y="2"/>
                  </a:lnTo>
                  <a:lnTo>
                    <a:pt x="13" y="2"/>
                  </a:lnTo>
                  <a:lnTo>
                    <a:pt x="15" y="6"/>
                  </a:lnTo>
                  <a:lnTo>
                    <a:pt x="15" y="6"/>
                  </a:lnTo>
                  <a:close/>
                  <a:moveTo>
                    <a:pt x="422" y="838"/>
                  </a:moveTo>
                  <a:lnTo>
                    <a:pt x="416" y="945"/>
                  </a:lnTo>
                  <a:lnTo>
                    <a:pt x="333" y="876"/>
                  </a:lnTo>
                  <a:lnTo>
                    <a:pt x="422" y="838"/>
                  </a:lnTo>
                  <a:close/>
                </a:path>
              </a:pathLst>
            </a:custGeom>
            <a:solidFill>
              <a:srgbClr val="000000"/>
            </a:solidFill>
            <a:ln w="1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4046400" y="4503600"/>
              <a:ext cx="1273320" cy="411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4046400" y="4503600"/>
              <a:ext cx="1273320" cy="411480"/>
            </a:xfrm>
            <a:prstGeom prst="rect">
              <a:avLst/>
            </a:prstGeom>
            <a:noFill/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Matthew Fisher</cp:lastModifiedBy>
  <dcterms:modified xsi:type="dcterms:W3CDTF">2005-09-26T13:49:49Z</dcterms:modified>
  <cp:revision>3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